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B78C37D-F01A-48EE-9415-BF53D1FA7B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C1F48B1-C973-4AE9-A744-F98505B8D8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C1E19B7-C04B-4AAB-9EB0-A274EDFB4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C16C7A4-4884-46E1-827E-8535FD3058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0263ED9-F10C-4701-90C4-CA46525D95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575644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007C80C-AC04-4B85-87A8-03F9362F26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708A653-8BC3-4C59-B160-79CD5E8976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5149B9F-369D-4452-BDF5-72A5A11E1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9E068FA-B32E-4308-9790-00F9ACABD6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9007CA5-37E6-4094-BBB6-8412E5DC9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832682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800C720D-CCF4-4E84-94E2-3ADBF935B6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F4E8EEB-0E1D-4CE5-8DF4-A3A2A16FA7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684BF6A-2E66-4735-9BB3-2DEFBFF862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35C1388-42AF-449A-9FA5-1876D40B2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492FAB9-EDFF-4EB6-89D5-A60CF13B78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57578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7E82A9A-861D-41C4-AA24-E27BEA790B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6C9532A-14D6-427B-A422-A47FF614A7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FD66D84-37AF-4380-8CBF-396F149D5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1E419B6-C332-4E98-94A6-C73555AB3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D9DFDA8-2CBB-444D-93C8-9BF978CD1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644695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F97D037-C058-41A2-BE9A-18EEDAD55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AF41DB1-7579-4657-A080-485390DDE9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6E803F2-AEF9-4DB8-A9F8-DDE13DD68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F993837-E812-4487-8AC3-E36C8BAEEC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EA31F5E-3338-465A-8178-1919A976A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208759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408A868-C3DB-4458-A2FA-BF92FC46E0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1DBA90D-B6BC-4DA2-A50E-5B9232CEA9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19D6946-BEE0-4610-BD43-9DD0DBCBCA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CE12F37-AEB9-485B-8D12-8F2D9431B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035D511-339E-4C05-A905-2251EC5295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B2BE62B-D6BA-4795-927F-457B71CD0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985520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B23AF02-0AD4-4397-99B8-6016A3059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E59E250-7E12-49CE-9E00-86D9A3ACC5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53A36AF-5D35-4CF7-A7FA-FBC4278412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72A5E65A-7331-484D-8EAA-B7ADEE069D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634B4FB2-62CF-46AB-8308-9F099143C3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063E39C4-80B1-4FCC-A2F2-84304E7F25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E9FE66A-1A9E-4C63-8F34-101DF11F37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893EE281-8126-446F-BCF0-5A6415C82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660021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25F1725-8246-4965-BC0C-B858419D7B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94D8B060-114A-4614-B73B-9F8DF673F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2AC0A6D1-0BE9-4816-9AA2-EC7399CFA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7586C3DB-810A-4AC1-AD33-2E422564D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025033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6ECF1041-D862-4379-8B15-3EB70AA9A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0C1D7056-1B7D-421E-B5C7-E0F720782C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EBA0DEE-C6C4-47D4-B7A4-C601AFBA5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417522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DD5654-7C9D-4830-B7F2-34079480CC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F724288-D011-42E6-AB93-444BB319C5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CDF5FC7-E374-4187-BCA4-9D607862F7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1D5071C-384A-4237-8738-C9F45BFD6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1EFEA7B-154E-4637-87FA-C165BB961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DE79313-0DCD-4959-822B-AB2608E9C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5744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16E4E4A-B850-48C8-973E-5718A125DF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BA937653-3D17-4316-8941-B816032268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1A023FA-C8AE-4A63-8A97-D5EB6AFF4D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3BB9563-4B9B-4CEB-A3AB-4FC01ECB2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7D46FB1-E611-425F-B271-E1204D192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5E766A4-2664-4F5F-9B83-0056E6C72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623296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E6B423A-8F69-41B7-A64D-73A823CBA7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5ED15B9-9C6D-45A3-9FA5-108FCCB843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B199B47-D44C-4780-BB98-C4E32B4EAD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E43EA3A-A670-40AB-8EBA-684B8CD027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3FDED2D-4089-4762-95CF-277D6497D1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08594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ángulo 16">
            <a:extLst>
              <a:ext uri="{FF2B5EF4-FFF2-40B4-BE49-F238E27FC236}">
                <a16:creationId xmlns:a16="http://schemas.microsoft.com/office/drawing/2014/main" id="{0B9266E7-A0DD-4992-B779-F32D9CD71C63}"/>
              </a:ext>
            </a:extLst>
          </p:cNvPr>
          <p:cNvSpPr/>
          <p:nvPr/>
        </p:nvSpPr>
        <p:spPr>
          <a:xfrm>
            <a:off x="246650" y="5106042"/>
            <a:ext cx="11063033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400" b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igure S1.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Morphological</a:t>
            </a:r>
            <a:r>
              <a:rPr lang="en-US" sz="1400" b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propagative structures of the isolate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ol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-UDC10 observed on CDA plates. (A) Morphology of the colonies showing the typical pink pale mycelia of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usarium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spp. (B) Optical microscopy images showing microconidia over short </a:t>
            </a:r>
            <a:r>
              <a:rPr lang="en-US" sz="1400" dirty="0" err="1">
                <a:latin typeface="Palatino Linotype" panose="02040502050505030304" pitchFamily="18" charset="0"/>
                <a:ea typeface="Times New Roman" panose="02020603050405020304" pitchFamily="18" charset="0"/>
              </a:rPr>
              <a:t>monophialids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conforming </a:t>
            </a:r>
            <a:r>
              <a:rPr lang="en-US" sz="1400" dirty="0" err="1">
                <a:latin typeface="Palatino Linotype" panose="02040502050505030304" pitchFamily="18" charset="0"/>
                <a:ea typeface="Times New Roman" panose="02020603050405020304" pitchFamily="18" charset="0"/>
              </a:rPr>
              <a:t>pseudoheads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, macro and microconidia formed with typical curved form and septs, macroconidia forming </a:t>
            </a:r>
            <a:r>
              <a:rPr lang="en-US" sz="1400" dirty="0" err="1">
                <a:latin typeface="Palatino Linotype" panose="02040502050505030304" pitchFamily="18" charset="0"/>
                <a:ea typeface="Times New Roman" panose="02020603050405020304" pitchFamily="18" charset="0"/>
              </a:rPr>
              <a:t>sporodochia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and intercalary or terminal chlamydospores on hyphae, (magnification of 40X). (C) Environmental scanning electron microscopy showing microconidia over short </a:t>
            </a:r>
            <a:r>
              <a:rPr lang="en-US" sz="1400" dirty="0" err="1">
                <a:latin typeface="Palatino Linotype" panose="02040502050505030304" pitchFamily="18" charset="0"/>
                <a:ea typeface="Times New Roman" panose="02020603050405020304" pitchFamily="18" charset="0"/>
              </a:rPr>
              <a:t>monophialids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, oval </a:t>
            </a:r>
            <a:r>
              <a:rPr lang="en-US" sz="1400">
                <a:latin typeface="Palatino Linotype" panose="02040502050505030304" pitchFamily="18" charset="0"/>
                <a:ea typeface="Times New Roman" panose="02020603050405020304" pitchFamily="18" charset="0"/>
              </a:rPr>
              <a:t>microconidia and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intercalary or terminal chlamydospores on hyphae, (magnification of 5000X). Pictures from Magda R. Gómez, Sandra L. Carmona and Walter Lopez. Photographic records from Agricultural Microbiology Group, AGROSAVIA.</a:t>
            </a:r>
          </a:p>
          <a:p>
            <a:pPr algn="just">
              <a:spcAft>
                <a:spcPts val="0"/>
              </a:spcAft>
            </a:pPr>
            <a:endParaRPr lang="en-US" sz="14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20" name="Grupo 19">
            <a:extLst>
              <a:ext uri="{FF2B5EF4-FFF2-40B4-BE49-F238E27FC236}">
                <a16:creationId xmlns:a16="http://schemas.microsoft.com/office/drawing/2014/main" id="{0AD8DB35-8912-4318-ACD6-89F8E5F892B3}"/>
              </a:ext>
            </a:extLst>
          </p:cNvPr>
          <p:cNvGrpSpPr/>
          <p:nvPr/>
        </p:nvGrpSpPr>
        <p:grpSpPr>
          <a:xfrm>
            <a:off x="3144110" y="10472"/>
            <a:ext cx="6054620" cy="4805664"/>
            <a:chOff x="3144110" y="10472"/>
            <a:chExt cx="6054620" cy="4805664"/>
          </a:xfrm>
        </p:grpSpPr>
        <p:grpSp>
          <p:nvGrpSpPr>
            <p:cNvPr id="14" name="Grupo 13">
              <a:extLst>
                <a:ext uri="{FF2B5EF4-FFF2-40B4-BE49-F238E27FC236}">
                  <a16:creationId xmlns:a16="http://schemas.microsoft.com/office/drawing/2014/main" id="{A3DF15F7-D47D-4E32-B2D0-C4C667B0F901}"/>
                </a:ext>
              </a:extLst>
            </p:cNvPr>
            <p:cNvGrpSpPr/>
            <p:nvPr/>
          </p:nvGrpSpPr>
          <p:grpSpPr>
            <a:xfrm>
              <a:off x="3144110" y="10472"/>
              <a:ext cx="6013141" cy="4764953"/>
              <a:chOff x="2653781" y="1030883"/>
              <a:chExt cx="6013141" cy="4764953"/>
            </a:xfrm>
          </p:grpSpPr>
          <p:sp>
            <p:nvSpPr>
              <p:cNvPr id="13" name="Rectángulo 12">
                <a:extLst>
                  <a:ext uri="{FF2B5EF4-FFF2-40B4-BE49-F238E27FC236}">
                    <a16:creationId xmlns:a16="http://schemas.microsoft.com/office/drawing/2014/main" id="{43E40C74-7FB3-4434-90BB-4EE8A9E6924C}"/>
                  </a:ext>
                </a:extLst>
              </p:cNvPr>
              <p:cNvSpPr/>
              <p:nvPr/>
            </p:nvSpPr>
            <p:spPr>
              <a:xfrm>
                <a:off x="3246782" y="1043272"/>
                <a:ext cx="4638261" cy="167341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s-CO"/>
              </a:p>
            </p:txBody>
          </p:sp>
          <p:pic>
            <p:nvPicPr>
              <p:cNvPr id="28" name="Imagen 27">
                <a:extLst>
                  <a:ext uri="{FF2B5EF4-FFF2-40B4-BE49-F238E27FC236}">
                    <a16:creationId xmlns:a16="http://schemas.microsoft.com/office/drawing/2014/main" id="{A10C313E-C92C-4305-8C9A-D8F17E9D408C}"/>
                  </a:ext>
                </a:extLst>
              </p:cNvPr>
              <p:cNvPicPr/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695261" y="2784279"/>
                <a:ext cx="5971661" cy="3011557"/>
              </a:xfrm>
              <a:prstGeom prst="rect">
                <a:avLst/>
              </a:prstGeom>
              <a:noFill/>
            </p:spPr>
          </p:pic>
          <p:grpSp>
            <p:nvGrpSpPr>
              <p:cNvPr id="3" name="Grupo 2">
                <a:extLst>
                  <a:ext uri="{FF2B5EF4-FFF2-40B4-BE49-F238E27FC236}">
                    <a16:creationId xmlns:a16="http://schemas.microsoft.com/office/drawing/2014/main" id="{B4E106CA-6AFF-45D3-B6D4-94B212697283}"/>
                  </a:ext>
                </a:extLst>
              </p:cNvPr>
              <p:cNvGrpSpPr/>
              <p:nvPr/>
            </p:nvGrpSpPr>
            <p:grpSpPr>
              <a:xfrm rot="5400000">
                <a:off x="4761298" y="-321319"/>
                <a:ext cx="1503880" cy="4346057"/>
                <a:chOff x="7349955" y="1066686"/>
                <a:chExt cx="1649516" cy="5166837"/>
              </a:xfrm>
            </p:grpSpPr>
            <p:grpSp>
              <p:nvGrpSpPr>
                <p:cNvPr id="4" name="Grupo 3">
                  <a:extLst>
                    <a:ext uri="{FF2B5EF4-FFF2-40B4-BE49-F238E27FC236}">
                      <a16:creationId xmlns:a16="http://schemas.microsoft.com/office/drawing/2014/main" id="{7D4828DA-DD06-4F1F-B3CD-9A67610C497A}"/>
                    </a:ext>
                  </a:extLst>
                </p:cNvPr>
                <p:cNvGrpSpPr/>
                <p:nvPr/>
              </p:nvGrpSpPr>
              <p:grpSpPr>
                <a:xfrm rot="5400000">
                  <a:off x="5623185" y="2793456"/>
                  <a:ext cx="5103056" cy="1649516"/>
                  <a:chOff x="348875" y="-305273"/>
                  <a:chExt cx="5103534" cy="1649729"/>
                </a:xfrm>
              </p:grpSpPr>
              <p:pic>
                <p:nvPicPr>
                  <p:cNvPr id="10" name="Imagen 9">
                    <a:extLst>
                      <a:ext uri="{FF2B5EF4-FFF2-40B4-BE49-F238E27FC236}">
                        <a16:creationId xmlns:a16="http://schemas.microsoft.com/office/drawing/2014/main" id="{4F7DEAD8-37C2-41E8-B0DF-0AB220D2E9B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 cstate="screen">
                    <a:extLst>
                      <a:ext uri="{BEBA8EAE-BF5A-486C-A8C5-ECC9F3942E4B}">
                        <a14:imgProps xmlns:a14="http://schemas.microsoft.com/office/drawing/2010/main">
                          <a14:imgLayer r:embed="rId4">
                            <a14:imgEffect>
                              <a14:colorTemperature colorTemp="7200"/>
                            </a14:imgEffect>
                            <a14:imgEffect>
                              <a14:saturation sat="66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18398" r="1044" b="1383"/>
                  <a:stretch/>
                </p:blipFill>
                <p:spPr>
                  <a:xfrm>
                    <a:off x="2024482" y="-305259"/>
                    <a:ext cx="1648481" cy="1626909"/>
                  </a:xfrm>
                  <a:prstGeom prst="ellipse">
                    <a:avLst/>
                  </a:prstGeom>
                </p:spPr>
              </p:pic>
              <p:pic>
                <p:nvPicPr>
                  <p:cNvPr id="11" name="Imagen 10" descr="C:\Users\INSPIRON11\OneDrive para la Empresa\Fotos tesis\Aislamiento Cundinamarca\M9R...JPG">
                    <a:extLst>
                      <a:ext uri="{FF2B5EF4-FFF2-40B4-BE49-F238E27FC236}">
                        <a16:creationId xmlns:a16="http://schemas.microsoft.com/office/drawing/2014/main" id="{CBEC6435-77BD-4999-905E-57194B52623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 cstate="screen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3055" t="2862" r="5641" b="603"/>
                  <a:stretch/>
                </p:blipFill>
                <p:spPr bwMode="auto">
                  <a:xfrm>
                    <a:off x="348875" y="-248792"/>
                    <a:ext cx="1641696" cy="1583370"/>
                  </a:xfrm>
                  <a:prstGeom prst="ellipse">
                    <a:avLst/>
                  </a:prstGeom>
                  <a:noFill/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pic>
                <p:nvPicPr>
                  <p:cNvPr id="12" name="Imagen 11" descr="C:\Users\INSPIRON11\OneDrive para la Empresa\Fotos tesis\Aislamientos Antioquia\37R (2).JPG">
                    <a:extLst>
                      <a:ext uri="{FF2B5EF4-FFF2-40B4-BE49-F238E27FC236}">
                        <a16:creationId xmlns:a16="http://schemas.microsoft.com/office/drawing/2014/main" id="{6F3D2448-2F49-42C0-94CB-751119CD406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 cstate="screen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colorTemperature colorTemp="72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r="14763"/>
                  <a:stretch/>
                </p:blipFill>
                <p:spPr bwMode="auto">
                  <a:xfrm>
                    <a:off x="3684390" y="-305273"/>
                    <a:ext cx="1768019" cy="1649729"/>
                  </a:xfrm>
                  <a:prstGeom prst="ellipse">
                    <a:avLst/>
                  </a:prstGeom>
                  <a:noFill/>
                  <a:ln>
                    <a:noFill/>
                  </a:ln>
                </p:spPr>
              </p:pic>
            </p:grpSp>
            <p:sp>
              <p:nvSpPr>
                <p:cNvPr id="5" name="CuadroTexto 4">
                  <a:extLst>
                    <a:ext uri="{FF2B5EF4-FFF2-40B4-BE49-F238E27FC236}">
                      <a16:creationId xmlns:a16="http://schemas.microsoft.com/office/drawing/2014/main" id="{9C32533A-607C-45AA-A6F0-F954EDAE34E6}"/>
                    </a:ext>
                  </a:extLst>
                </p:cNvPr>
                <p:cNvSpPr txBox="1"/>
                <p:nvPr/>
              </p:nvSpPr>
              <p:spPr>
                <a:xfrm>
                  <a:off x="8271360" y="5887954"/>
                  <a:ext cx="546867" cy="2614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CO" sz="788" b="1" dirty="0">
                      <a:solidFill>
                        <a:schemeClr val="bg1"/>
                      </a:solidFill>
                    </a:rPr>
                    <a:t>2 cm</a:t>
                  </a:r>
                  <a:endParaRPr lang="en-US" sz="788" b="1" dirty="0">
                    <a:solidFill>
                      <a:schemeClr val="bg1"/>
                    </a:solidFill>
                  </a:endParaRPr>
                </a:p>
              </p:txBody>
            </p:sp>
            <p:grpSp>
              <p:nvGrpSpPr>
                <p:cNvPr id="6" name="Grupo 5">
                  <a:extLst>
                    <a:ext uri="{FF2B5EF4-FFF2-40B4-BE49-F238E27FC236}">
                      <a16:creationId xmlns:a16="http://schemas.microsoft.com/office/drawing/2014/main" id="{E6E07F1F-3516-4F45-A4C5-01B9ECD1EDD4}"/>
                    </a:ext>
                  </a:extLst>
                </p:cNvPr>
                <p:cNvGrpSpPr/>
                <p:nvPr/>
              </p:nvGrpSpPr>
              <p:grpSpPr>
                <a:xfrm rot="5400000">
                  <a:off x="8385024" y="5986101"/>
                  <a:ext cx="178319" cy="316525"/>
                  <a:chOff x="11387365" y="2702256"/>
                  <a:chExt cx="214122" cy="971271"/>
                </a:xfrm>
              </p:grpSpPr>
              <p:cxnSp>
                <p:nvCxnSpPr>
                  <p:cNvPr id="7" name="Conector recto 6">
                    <a:extLst>
                      <a:ext uri="{FF2B5EF4-FFF2-40B4-BE49-F238E27FC236}">
                        <a16:creationId xmlns:a16="http://schemas.microsoft.com/office/drawing/2014/main" id="{C335D20B-70B4-4FC4-AD17-F253F8B814D0}"/>
                      </a:ext>
                    </a:extLst>
                  </p:cNvPr>
                  <p:cNvCxnSpPr/>
                  <p:nvPr/>
                </p:nvCxnSpPr>
                <p:spPr>
                  <a:xfrm>
                    <a:off x="11494096" y="2702257"/>
                    <a:ext cx="0" cy="957214"/>
                  </a:xfrm>
                  <a:prstGeom prst="line">
                    <a:avLst/>
                  </a:prstGeom>
                  <a:ln w="190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" name="Conector recto 7">
                    <a:extLst>
                      <a:ext uri="{FF2B5EF4-FFF2-40B4-BE49-F238E27FC236}">
                        <a16:creationId xmlns:a16="http://schemas.microsoft.com/office/drawing/2014/main" id="{BE972CBF-9A00-4E89-890A-7C7D43A0AA6A}"/>
                      </a:ext>
                    </a:extLst>
                  </p:cNvPr>
                  <p:cNvCxnSpPr/>
                  <p:nvPr/>
                </p:nvCxnSpPr>
                <p:spPr>
                  <a:xfrm>
                    <a:off x="11395880" y="2702256"/>
                    <a:ext cx="205607" cy="0"/>
                  </a:xfrm>
                  <a:prstGeom prst="line">
                    <a:avLst/>
                  </a:prstGeom>
                  <a:ln w="190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" name="Conector recto 8">
                    <a:extLst>
                      <a:ext uri="{FF2B5EF4-FFF2-40B4-BE49-F238E27FC236}">
                        <a16:creationId xmlns:a16="http://schemas.microsoft.com/office/drawing/2014/main" id="{2921D3B1-4A0D-4489-A91E-36E659570E9A}"/>
                      </a:ext>
                    </a:extLst>
                  </p:cNvPr>
                  <p:cNvCxnSpPr/>
                  <p:nvPr/>
                </p:nvCxnSpPr>
                <p:spPr>
                  <a:xfrm>
                    <a:off x="11387365" y="3673527"/>
                    <a:ext cx="205607" cy="0"/>
                  </a:xfrm>
                  <a:prstGeom prst="line">
                    <a:avLst/>
                  </a:prstGeom>
                  <a:ln w="190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" name="CuadroTexto 1">
                <a:extLst>
                  <a:ext uri="{FF2B5EF4-FFF2-40B4-BE49-F238E27FC236}">
                    <a16:creationId xmlns:a16="http://schemas.microsoft.com/office/drawing/2014/main" id="{BCD8BAF0-5D59-401D-9F2C-F80F4181618A}"/>
                  </a:ext>
                </a:extLst>
              </p:cNvPr>
              <p:cNvSpPr txBox="1"/>
              <p:nvPr/>
            </p:nvSpPr>
            <p:spPr>
              <a:xfrm>
                <a:off x="3177242" y="1030883"/>
                <a:ext cx="35137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CO" b="1" dirty="0">
                    <a:solidFill>
                      <a:schemeClr val="bg1"/>
                    </a:solidFill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5" name="CuadroTexto 14">
                <a:extLst>
                  <a:ext uri="{FF2B5EF4-FFF2-40B4-BE49-F238E27FC236}">
                    <a16:creationId xmlns:a16="http://schemas.microsoft.com/office/drawing/2014/main" id="{278DD55E-3FCF-4580-BF65-6156F5096529}"/>
                  </a:ext>
                </a:extLst>
              </p:cNvPr>
              <p:cNvSpPr txBox="1"/>
              <p:nvPr/>
            </p:nvSpPr>
            <p:spPr>
              <a:xfrm>
                <a:off x="2653781" y="2707286"/>
                <a:ext cx="33695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CO" b="1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6981A738-344E-4DDD-BBE2-7BACBE230502}"/>
                </a:ext>
              </a:extLst>
            </p:cNvPr>
            <p:cNvSpPr txBox="1"/>
            <p:nvPr/>
          </p:nvSpPr>
          <p:spPr>
            <a:xfrm>
              <a:off x="6158982" y="1693503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O" b="1" dirty="0">
                  <a:solidFill>
                    <a:schemeClr val="bg1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pic>
          <p:nvPicPr>
            <p:cNvPr id="19" name="Imagen 18">
              <a:extLst>
                <a:ext uri="{FF2B5EF4-FFF2-40B4-BE49-F238E27FC236}">
                  <a16:creationId xmlns:a16="http://schemas.microsoft.com/office/drawing/2014/main" id="{D3BE461D-B4BD-4923-AEA7-658C17470F81}"/>
                </a:ext>
              </a:extLst>
            </p:cNvPr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027" t="51050"/>
            <a:stretch/>
          </p:blipFill>
          <p:spPr bwMode="auto">
            <a:xfrm>
              <a:off x="6215068" y="3301393"/>
              <a:ext cx="1431647" cy="1474143"/>
            </a:xfrm>
            <a:prstGeom prst="rect">
              <a:avLst/>
            </a:prstGeom>
            <a:noFill/>
          </p:spPr>
        </p:pic>
        <p:sp>
          <p:nvSpPr>
            <p:cNvPr id="16" name="Rectángulo 15">
              <a:extLst>
                <a:ext uri="{FF2B5EF4-FFF2-40B4-BE49-F238E27FC236}">
                  <a16:creationId xmlns:a16="http://schemas.microsoft.com/office/drawing/2014/main" id="{8A9189EB-6CB4-486D-B62B-C6210695CA50}"/>
                </a:ext>
              </a:extLst>
            </p:cNvPr>
            <p:cNvSpPr/>
            <p:nvPr/>
          </p:nvSpPr>
          <p:spPr>
            <a:xfrm>
              <a:off x="7719395" y="3292152"/>
              <a:ext cx="1479335" cy="152398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/>
            </a:p>
          </p:txBody>
        </p:sp>
      </p:grpSp>
    </p:spTree>
    <p:extLst>
      <p:ext uri="{BB962C8B-B14F-4D97-AF65-F5344CB8AC3E}">
        <p14:creationId xmlns:p14="http://schemas.microsoft.com/office/powerpoint/2010/main" val="40317234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7</TotalTime>
  <Words>130</Words>
  <Application>Microsoft Office PowerPoint</Application>
  <PresentationFormat>Panorámica</PresentationFormat>
  <Paragraphs>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uricio Soto Suárez</dc:creator>
  <cp:lastModifiedBy>Mauricio Soto Suárez</cp:lastModifiedBy>
  <cp:revision>18</cp:revision>
  <dcterms:created xsi:type="dcterms:W3CDTF">2019-03-04T18:45:41Z</dcterms:created>
  <dcterms:modified xsi:type="dcterms:W3CDTF">2020-01-17T00:24:01Z</dcterms:modified>
</cp:coreProperties>
</file>